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6" r:id="rId3"/>
    <p:sldId id="259" r:id="rId4"/>
    <p:sldId id="257" r:id="rId5"/>
    <p:sldId id="258" r:id="rId6"/>
    <p:sldId id="262" r:id="rId7"/>
    <p:sldId id="261" r:id="rId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04" autoAdjust="0"/>
    <p:restoredTop sz="94660"/>
  </p:normalViewPr>
  <p:slideViewPr>
    <p:cSldViewPr snapToGrid="0">
      <p:cViewPr varScale="1">
        <p:scale>
          <a:sx n="69" d="100"/>
          <a:sy n="69" d="100"/>
        </p:scale>
        <p:origin x="10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644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749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8034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052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421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2573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932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640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226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589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901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B0CD5-7615-45C4-BEF3-62B2D18CA99B}" type="datetimeFigureOut">
              <a:rPr lang="en-GB" smtClean="0"/>
              <a:t>13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FCEFD-1F03-4672-B387-B43A4D44C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4275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57178" y="1419226"/>
            <a:ext cx="6144712" cy="3416523"/>
            <a:chOff x="1833909" y="1419226"/>
            <a:chExt cx="6047917" cy="341652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510" b="3938"/>
            <a:stretch/>
          </p:blipFill>
          <p:spPr>
            <a:xfrm rot="5400000">
              <a:off x="2177991" y="1450107"/>
              <a:ext cx="2518823" cy="2557296"/>
            </a:xfrm>
            <a:prstGeom prst="rect">
              <a:avLst/>
            </a:prstGeom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054845" y="3864955"/>
              <a:ext cx="576000" cy="3044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98" b="3938"/>
            <a:stretch/>
          </p:blipFill>
          <p:spPr>
            <a:xfrm rot="5400000">
              <a:off x="4798491" y="1434717"/>
              <a:ext cx="2520000" cy="2589252"/>
            </a:xfrm>
            <a:prstGeom prst="rect">
              <a:avLst/>
            </a:prstGeom>
          </p:spPr>
        </p:pic>
        <p:cxnSp>
          <p:nvCxnSpPr>
            <p:cNvPr id="6" name="Straight Connector 5"/>
            <p:cNvCxnSpPr/>
            <p:nvPr/>
          </p:nvCxnSpPr>
          <p:spPr>
            <a:xfrm flipV="1">
              <a:off x="6727122" y="3861911"/>
              <a:ext cx="576000" cy="3044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 flipV="1">
              <a:off x="4501032" y="4198641"/>
              <a:ext cx="576000" cy="3044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2114116" y="1419226"/>
              <a:ext cx="266821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51</a:t>
              </a:r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726259" y="1424978"/>
              <a:ext cx="266821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51</a:t>
              </a:r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33909" y="4235585"/>
              <a:ext cx="6047917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1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ngle z-frame from middle of early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zygo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ucleus showing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51 localization (red) with ASY1 (green) marking the chromosome axis. The right-hand image shows RAD51 foci marked using the NIS Elements (Nikon) count tool (red crosses). Bar = 10 µM.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930731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68945" y="1412584"/>
            <a:ext cx="5098473" cy="4137681"/>
            <a:chOff x="2068945" y="1412584"/>
            <a:chExt cx="5098473" cy="4137681"/>
          </a:xfrm>
        </p:grpSpPr>
        <p:sp>
          <p:nvSpPr>
            <p:cNvPr id="16" name="Rectangle 15"/>
            <p:cNvSpPr/>
            <p:nvPr/>
          </p:nvSpPr>
          <p:spPr>
            <a:xfrm>
              <a:off x="2661557" y="1532710"/>
              <a:ext cx="2141570" cy="276999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P1 </a:t>
              </a:r>
              <a:r>
                <a:rPr lang="el-GR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2A.X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68945" y="4780824"/>
              <a:ext cx="5098473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2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‘Presynaptic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’ ZYP1 foci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 late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pto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Before SC extension begins, ZYP1 forms axis-associated foci throughout the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cleus. 97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of ZYP1 foci (green) are at DSB sites, marked by 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H2A.X (red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(n =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77)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marks the chromosome axes (blu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. Bar = 10 µM.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2342169" y="1412584"/>
              <a:ext cx="4307606" cy="3090324"/>
              <a:chOff x="2342169" y="1412584"/>
              <a:chExt cx="4307606" cy="3090324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2342169" y="1412584"/>
                <a:ext cx="4307606" cy="3090324"/>
                <a:chOff x="2342169" y="1412584"/>
                <a:chExt cx="4307606" cy="3090324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42169" y="1521194"/>
                  <a:ext cx="2730156" cy="288000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31"/>
                <a:stretch/>
              </p:blipFill>
              <p:spPr>
                <a:xfrm>
                  <a:off x="5080967" y="2445508"/>
                  <a:ext cx="1568807" cy="1027830"/>
                </a:xfrm>
                <a:prstGeom prst="rect">
                  <a:avLst/>
                </a:prstGeom>
              </p:spPr>
            </p:pic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355"/>
                <a:stretch/>
              </p:blipFill>
              <p:spPr>
                <a:xfrm>
                  <a:off x="5080966" y="3480741"/>
                  <a:ext cx="1568807" cy="1022167"/>
                </a:xfrm>
                <a:prstGeom prst="rect">
                  <a:avLst/>
                </a:prstGeom>
              </p:spPr>
            </p:pic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-1" b="4946"/>
                <a:stretch/>
              </p:blipFill>
              <p:spPr>
                <a:xfrm>
                  <a:off x="5080968" y="1412584"/>
                  <a:ext cx="1568807" cy="1026583"/>
                </a:xfrm>
                <a:prstGeom prst="rect">
                  <a:avLst/>
                </a:prstGeom>
              </p:spPr>
            </p:pic>
            <p:sp>
              <p:nvSpPr>
                <p:cNvPr id="14" name="Rectangle 13"/>
                <p:cNvSpPr>
                  <a:spLocks noChangeAspect="1"/>
                </p:cNvSpPr>
                <p:nvPr/>
              </p:nvSpPr>
              <p:spPr>
                <a:xfrm flipH="1">
                  <a:off x="4279067" y="2526691"/>
                  <a:ext cx="649884" cy="469870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cxnSp>
            <p:nvCxnSpPr>
              <p:cNvPr id="18" name="Straight Connector 17"/>
              <p:cNvCxnSpPr/>
              <p:nvPr/>
            </p:nvCxnSpPr>
            <p:spPr>
              <a:xfrm>
                <a:off x="4304949" y="4295485"/>
                <a:ext cx="662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Rectangle 18"/>
            <p:cNvSpPr/>
            <p:nvPr/>
          </p:nvSpPr>
          <p:spPr>
            <a:xfrm>
              <a:off x="2333066" y="1518733"/>
              <a:ext cx="169579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P1 </a:t>
              </a:r>
              <a:r>
                <a:rPr lang="el-GR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2A.X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5442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36411" y="867034"/>
            <a:ext cx="9405837" cy="3284859"/>
            <a:chOff x="171759" y="867034"/>
            <a:chExt cx="9405837" cy="328485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8679" y="900000"/>
              <a:ext cx="2326927" cy="2340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50669" y="900000"/>
              <a:ext cx="2326927" cy="2340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6412" y="900000"/>
              <a:ext cx="2326927" cy="234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638355" y="3721006"/>
              <a:ext cx="868387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iple localization of ZYP1 (green), CENH3 (red) and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ASY1 (blue),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n late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pto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‘Presynaptic’ ZYP1 foci do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t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ocalis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with CENH3-marked regions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Bar = 10 µM. 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16783" y="900000"/>
              <a:ext cx="2326927" cy="2340000"/>
              <a:chOff x="216783" y="900000"/>
              <a:chExt cx="2326927" cy="2340000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783" y="900000"/>
                <a:ext cx="2326927" cy="2340000"/>
              </a:xfrm>
              <a:prstGeom prst="rect">
                <a:avLst/>
              </a:prstGeom>
            </p:spPr>
          </p:pic>
          <p:cxnSp>
            <p:nvCxnSpPr>
              <p:cNvPr id="9" name="Straight Connector 8"/>
              <p:cNvCxnSpPr/>
              <p:nvPr/>
            </p:nvCxnSpPr>
            <p:spPr>
              <a:xfrm flipV="1">
                <a:off x="1950336" y="3113665"/>
                <a:ext cx="495905" cy="3044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Rectangle 10"/>
            <p:cNvSpPr/>
            <p:nvPr/>
          </p:nvSpPr>
          <p:spPr>
            <a:xfrm>
              <a:off x="171759" y="872194"/>
              <a:ext cx="169579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Y1 </a:t>
              </a:r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P1 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NH3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7236413" y="892862"/>
              <a:ext cx="121791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P1 </a:t>
              </a:r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NH3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517161" y="869614"/>
              <a:ext cx="169579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P1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878065" y="867034"/>
              <a:ext cx="169579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NH3</a:t>
              </a:r>
              <a:endParaRPr lang="en-GB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80316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13323" y="1257772"/>
            <a:ext cx="6237682" cy="3753190"/>
            <a:chOff x="1913323" y="1257772"/>
            <a:chExt cx="6237682" cy="3753190"/>
          </a:xfrm>
        </p:grpSpPr>
        <p:sp>
          <p:nvSpPr>
            <p:cNvPr id="12" name="TextBox 11"/>
            <p:cNvSpPr txBox="1"/>
            <p:nvPr/>
          </p:nvSpPr>
          <p:spPr>
            <a:xfrm>
              <a:off x="1930122" y="4410798"/>
              <a:ext cx="551846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4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C1 and RAD51 localisation in late prophase I. Very few DMC1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A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 RAD51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B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ci (red) remain associated with the SC (marked by ZYP1, green). DNA is stained with DAPI (blue). Bar = 10 µM.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/>
            <p:cNvGrpSpPr>
              <a:grpSpLocks noChangeAspect="1"/>
            </p:cNvGrpSpPr>
            <p:nvPr/>
          </p:nvGrpSpPr>
          <p:grpSpPr>
            <a:xfrm>
              <a:off x="1913323" y="1257772"/>
              <a:ext cx="6237682" cy="2851126"/>
              <a:chOff x="1637672" y="4918535"/>
              <a:chExt cx="3988063" cy="1877665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1637672" y="4918535"/>
                <a:ext cx="3988063" cy="1877665"/>
                <a:chOff x="2683600" y="8450338"/>
                <a:chExt cx="3988062" cy="1822867"/>
              </a:xfrm>
            </p:grpSpPr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216" t="2551" r="3771" b="4710"/>
                <a:stretch/>
              </p:blipFill>
              <p:spPr>
                <a:xfrm>
                  <a:off x="4537114" y="8473205"/>
                  <a:ext cx="1685454" cy="1800000"/>
                </a:xfrm>
                <a:prstGeom prst="rect">
                  <a:avLst/>
                </a:prstGeom>
              </p:spPr>
            </p:pic>
            <p:pic>
              <p:nvPicPr>
                <p:cNvPr id="18" name="Picture 17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4340" y="8473205"/>
                  <a:ext cx="1821819" cy="1800000"/>
                </a:xfrm>
                <a:prstGeom prst="rect">
                  <a:avLst/>
                </a:prstGeom>
              </p:spPr>
            </p:pic>
            <p:sp>
              <p:nvSpPr>
                <p:cNvPr id="19" name="TextBox 18"/>
                <p:cNvSpPr txBox="1"/>
                <p:nvPr/>
              </p:nvSpPr>
              <p:spPr>
                <a:xfrm>
                  <a:off x="4524423" y="8450338"/>
                  <a:ext cx="714071" cy="196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GB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683600" y="8450340"/>
                  <a:ext cx="265966" cy="196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GB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Rectangle 20"/>
                <p:cNvSpPr/>
                <p:nvPr/>
              </p:nvSpPr>
              <p:spPr>
                <a:xfrm>
                  <a:off x="3611348" y="8456492"/>
                  <a:ext cx="1405425" cy="1770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YP1 </a:t>
                  </a:r>
                  <a:r>
                    <a:rPr lang="en-GB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MC1</a:t>
                  </a:r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dirty="0" smtClean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Rectangle 21"/>
                <p:cNvSpPr/>
                <p:nvPr/>
              </p:nvSpPr>
              <p:spPr>
                <a:xfrm>
                  <a:off x="5266237" y="8462647"/>
                  <a:ext cx="1405425" cy="1770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YP1 </a:t>
                  </a:r>
                  <a:r>
                    <a:rPr lang="en-GB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D51</a:t>
                  </a:r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dirty="0" smtClean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5" name="Straight Connector 14"/>
              <p:cNvCxnSpPr/>
              <p:nvPr/>
            </p:nvCxnSpPr>
            <p:spPr>
              <a:xfrm>
                <a:off x="3127019" y="6734800"/>
                <a:ext cx="2736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4933117" y="6733431"/>
                <a:ext cx="180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71203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472199" y="1037677"/>
            <a:ext cx="7481454" cy="3643921"/>
            <a:chOff x="1472199" y="1037677"/>
            <a:chExt cx="7481454" cy="3643921"/>
          </a:xfrm>
        </p:grpSpPr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1708849" y="1037677"/>
              <a:ext cx="7165582" cy="2825780"/>
              <a:chOff x="1570603" y="1455516"/>
              <a:chExt cx="3684025" cy="1452812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35" t="4270" r="3158" b="833"/>
              <a:stretch/>
            </p:blipFill>
            <p:spPr>
              <a:xfrm rot="16200000">
                <a:off x="1697430" y="1341499"/>
                <a:ext cx="1440000" cy="1693653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2660776" y="1456126"/>
                <a:ext cx="1371805" cy="14241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 smtClean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YP1 </a:t>
                </a:r>
                <a:r>
                  <a:rPr lang="en-GB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H4</a:t>
                </a:r>
                <a:r>
                  <a:rPr lang="en-GB" sz="1200" b="1" dirty="0" smtClean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GB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581452" y="1462982"/>
                <a:ext cx="654548" cy="1582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GB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3272946" y="1455516"/>
                <a:ext cx="1981682" cy="1452812"/>
                <a:chOff x="3272946" y="1455516"/>
                <a:chExt cx="1981682" cy="1452812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16" t="6196" r="4890" b="6029"/>
                <a:stretch/>
              </p:blipFill>
              <p:spPr>
                <a:xfrm>
                  <a:off x="3272946" y="1468328"/>
                  <a:ext cx="1635164" cy="1440000"/>
                </a:xfrm>
                <a:prstGeom prst="rect">
                  <a:avLst/>
                </a:prstGeom>
              </p:spPr>
            </p:pic>
            <p:sp>
              <p:nvSpPr>
                <p:cNvPr id="9" name="Rectangle 8"/>
                <p:cNvSpPr/>
                <p:nvPr/>
              </p:nvSpPr>
              <p:spPr>
                <a:xfrm>
                  <a:off x="4323712" y="1456126"/>
                  <a:ext cx="930916" cy="14241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YP1 </a:t>
                  </a:r>
                  <a:r>
                    <a:rPr lang="en-GB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SH5</a:t>
                  </a:r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3295316" y="1455516"/>
                  <a:ext cx="658115" cy="1582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4567273" y="2855108"/>
                  <a:ext cx="3060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" name="Straight Connector 6"/>
              <p:cNvCxnSpPr/>
              <p:nvPr/>
            </p:nvCxnSpPr>
            <p:spPr>
              <a:xfrm>
                <a:off x="2966419" y="2856402"/>
                <a:ext cx="252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/>
            <p:cNvSpPr txBox="1"/>
            <p:nvPr/>
          </p:nvSpPr>
          <p:spPr>
            <a:xfrm>
              <a:off x="1472199" y="4250711"/>
              <a:ext cx="748145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5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SH4 and MSH5 localization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in late prophase I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y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chy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ery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few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SH4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A)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or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SH5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ci (red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main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associated with the SC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arked by ZYP1, green) but traces of staining remain in the nucleoli. Bar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= 10 µM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072354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214323" y="340657"/>
            <a:ext cx="7866236" cy="6248229"/>
            <a:chOff x="1214323" y="340657"/>
            <a:chExt cx="7866236" cy="6248229"/>
          </a:xfrm>
        </p:grpSpPr>
        <p:sp>
          <p:nvSpPr>
            <p:cNvPr id="5" name="TextBox 4"/>
            <p:cNvSpPr txBox="1"/>
            <p:nvPr/>
          </p:nvSpPr>
          <p:spPr>
            <a:xfrm>
              <a:off x="1214323" y="5988722"/>
              <a:ext cx="7866236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6.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I10 localization.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 late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pto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HEI10 (red) marks presynaptic ZYP1 foci (green). DNA is stained with DAPI (blue).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arly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iploten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ucleus (single z-frame). Arrows indicate example HEI10 foci (marked by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vHEI10 antibody, red) associated with short stretches of residual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YP1 staining (green) as chromosomes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esynapse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 Bar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µM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268548" y="340657"/>
              <a:ext cx="7812011" cy="5490426"/>
              <a:chOff x="1268548" y="340657"/>
              <a:chExt cx="7812011" cy="5490426"/>
            </a:xfrm>
          </p:grpSpPr>
          <p:grpSp>
            <p:nvGrpSpPr>
              <p:cNvPr id="16" name="Group 15"/>
              <p:cNvGrpSpPr>
                <a:grpSpLocks noChangeAspect="1"/>
              </p:cNvGrpSpPr>
              <p:nvPr/>
            </p:nvGrpSpPr>
            <p:grpSpPr>
              <a:xfrm>
                <a:off x="3457360" y="3024971"/>
                <a:ext cx="3640953" cy="2806112"/>
                <a:chOff x="2479586" y="2945944"/>
                <a:chExt cx="1876810" cy="1446472"/>
              </a:xfrm>
            </p:grpSpPr>
            <p:pic>
              <p:nvPicPr>
                <p:cNvPr id="17" name="Picture 6" descr="C:\Users\osmank\Documents\WHEAT\IMAGES\CADENZA\CAD_A1_Z1_H10\A1b_Z1g_HvH10-1r_12-11-18\a1b_z1g_hvh10-1r_12-11-18_019_z1_rg2.tif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79586" y="2952416"/>
                  <a:ext cx="1504272" cy="144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8" name="Rectangle 17"/>
                <p:cNvSpPr/>
                <p:nvPr/>
              </p:nvSpPr>
              <p:spPr>
                <a:xfrm>
                  <a:off x="3415271" y="2945944"/>
                  <a:ext cx="941125" cy="14278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YP1 </a:t>
                  </a:r>
                  <a:r>
                    <a:rPr lang="en-GB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I10</a:t>
                  </a:r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3790509" y="4359089"/>
                  <a:ext cx="1548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/>
                <p:cNvSpPr txBox="1"/>
                <p:nvPr/>
              </p:nvSpPr>
              <p:spPr>
                <a:xfrm>
                  <a:off x="2502357" y="2952978"/>
                  <a:ext cx="658115" cy="1586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GB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" name="Straight Arrow Connector 20"/>
                <p:cNvCxnSpPr/>
                <p:nvPr/>
              </p:nvCxnSpPr>
              <p:spPr>
                <a:xfrm flipV="1">
                  <a:off x="3910695" y="3520346"/>
                  <a:ext cx="1" cy="6972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Arrow Connector 21"/>
                <p:cNvCxnSpPr/>
                <p:nvPr/>
              </p:nvCxnSpPr>
              <p:spPr>
                <a:xfrm flipH="1" flipV="1">
                  <a:off x="3597544" y="3140548"/>
                  <a:ext cx="73617" cy="22582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Arrow Connector 22"/>
                <p:cNvCxnSpPr/>
                <p:nvPr/>
              </p:nvCxnSpPr>
              <p:spPr>
                <a:xfrm flipV="1">
                  <a:off x="2614004" y="4007897"/>
                  <a:ext cx="1" cy="6972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Arrow Connector 23"/>
                <p:cNvCxnSpPr/>
                <p:nvPr/>
              </p:nvCxnSpPr>
              <p:spPr>
                <a:xfrm flipV="1">
                  <a:off x="3254643" y="4289156"/>
                  <a:ext cx="60055" cy="1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oup 26"/>
              <p:cNvGrpSpPr/>
              <p:nvPr/>
            </p:nvGrpSpPr>
            <p:grpSpPr>
              <a:xfrm>
                <a:off x="1268548" y="347996"/>
                <a:ext cx="7403245" cy="2545610"/>
                <a:chOff x="1268548" y="394176"/>
                <a:chExt cx="7403245" cy="2545610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05" t="4989" r="10264" b="10537"/>
                <a:stretch/>
              </p:blipFill>
              <p:spPr>
                <a:xfrm>
                  <a:off x="6205701" y="419786"/>
                  <a:ext cx="2466092" cy="2520000"/>
                </a:xfrm>
                <a:prstGeom prst="rect">
                  <a:avLst/>
                </a:prstGeom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05" t="4987" r="10264" b="10537"/>
                <a:stretch/>
              </p:blipFill>
              <p:spPr>
                <a:xfrm>
                  <a:off x="1274525" y="419786"/>
                  <a:ext cx="2466092" cy="2520000"/>
                </a:xfrm>
                <a:prstGeom prst="rect">
                  <a:avLst/>
                </a:prstGeom>
              </p:spPr>
            </p:pic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05" t="4987" r="10264" b="10537"/>
                <a:stretch/>
              </p:blipFill>
              <p:spPr>
                <a:xfrm>
                  <a:off x="3740432" y="419786"/>
                  <a:ext cx="2466091" cy="2520000"/>
                </a:xfrm>
                <a:prstGeom prst="rect">
                  <a:avLst/>
                </a:prstGeom>
              </p:spPr>
            </p:pic>
            <p:sp>
              <p:nvSpPr>
                <p:cNvPr id="7" name="Rectangle 6"/>
                <p:cNvSpPr/>
                <p:nvPr/>
              </p:nvSpPr>
              <p:spPr>
                <a:xfrm>
                  <a:off x="2765801" y="397484"/>
                  <a:ext cx="1160640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YP1 </a:t>
                  </a:r>
                  <a:r>
                    <a:rPr lang="en-GB" sz="1200" b="1" dirty="0" smtClean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Rectangle 7"/>
                <p:cNvSpPr/>
                <p:nvPr/>
              </p:nvSpPr>
              <p:spPr>
                <a:xfrm>
                  <a:off x="5188111" y="394176"/>
                  <a:ext cx="1825753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I10</a:t>
                  </a:r>
                  <a:r>
                    <a:rPr lang="en-GB" sz="1200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dirty="0" smtClean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12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1268548" y="394611"/>
                  <a:ext cx="1276723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GB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8212320" y="2887824"/>
                  <a:ext cx="3960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Rectangle 5"/>
              <p:cNvSpPr/>
              <p:nvPr/>
            </p:nvSpPr>
            <p:spPr>
              <a:xfrm>
                <a:off x="7254806" y="340657"/>
                <a:ext cx="1825753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 smtClean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YP1 </a:t>
                </a:r>
                <a:r>
                  <a:rPr lang="en-GB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I10</a:t>
                </a:r>
                <a:r>
                  <a:rPr lang="en-GB" sz="1200" b="1" dirty="0" smtClean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2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GB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046615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6544" y="4350057"/>
            <a:ext cx="861937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cytologica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e-course of Cadenza meiosis using ASY1 or ZYP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calization in combination with 5-Bromo-2΄-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deoxyuridin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abelling at S-phase. Green shading indicates the presence of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abelled PMCs in anthers collected at specific time points after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jection. For each time point, the latest stage labelled by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was based on observing a minimum of 20 labelled nuclei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6911474"/>
              </p:ext>
            </p:extLst>
          </p:nvPr>
        </p:nvGraphicFramePr>
        <p:xfrm>
          <a:off x="646544" y="1690254"/>
          <a:ext cx="8619374" cy="2153642"/>
        </p:xfrm>
        <a:graphic>
          <a:graphicData uri="http://schemas.openxmlformats.org/drawingml/2006/table">
            <a:tbl>
              <a:tblPr firstRow="1" firstCol="1" bandRow="1"/>
              <a:tblGrid>
                <a:gridCol w="655778">
                  <a:extLst>
                    <a:ext uri="{9D8B030D-6E8A-4147-A177-3AD203B41FA5}">
                      <a16:colId xmlns:a16="http://schemas.microsoft.com/office/drawing/2014/main" val="2188724704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3879627794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3320838657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435507358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3107585741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3444485181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1931234304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906090798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925141236"/>
                    </a:ext>
                  </a:extLst>
                </a:gridCol>
                <a:gridCol w="884844">
                  <a:extLst>
                    <a:ext uri="{9D8B030D-6E8A-4147-A177-3AD203B41FA5}">
                      <a16:colId xmlns:a16="http://schemas.microsoft.com/office/drawing/2014/main" val="4133879398"/>
                    </a:ext>
                  </a:extLst>
                </a:gridCol>
              </a:tblGrid>
              <a:tr h="59844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me (h)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e</a:t>
                      </a:r>
                      <a:r>
                        <a:rPr lang="en-GB" sz="1050" b="1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Y1 labelling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Y1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oci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Y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hort</a:t>
                      </a:r>
                      <a:r>
                        <a:rPr lang="en-GB" sz="1050" b="1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linear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stretches,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larised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Y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nearizing,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stal enrichment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ZYP1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oci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ZYP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ort linear stretches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ZYP1 Synapsing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synapsis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etrads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5078900"/>
                  </a:ext>
                </a:extLst>
              </a:tr>
              <a:tr h="11275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1884703"/>
                  </a:ext>
                </a:extLst>
              </a:tr>
              <a:tr h="9664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5330560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6602864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175297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8203780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197321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1247552"/>
                  </a:ext>
                </a:extLst>
              </a:tr>
              <a:tr h="18637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05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96899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8284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2</TotalTime>
  <Words>557</Words>
  <Application>Microsoft Office PowerPoint</Application>
  <PresentationFormat>A4 Paper (210x297 mm)</PresentationFormat>
  <Paragraphs>10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oB 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 Osman (School of Biosciences)</dc:creator>
  <cp:lastModifiedBy>Kim Osman (School of Biosciences)</cp:lastModifiedBy>
  <cp:revision>62</cp:revision>
  <dcterms:created xsi:type="dcterms:W3CDTF">2020-11-19T12:26:18Z</dcterms:created>
  <dcterms:modified xsi:type="dcterms:W3CDTF">2021-01-13T18:34:50Z</dcterms:modified>
</cp:coreProperties>
</file>